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DCFA48-550A-4806-BD15-944DEED4241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8157F6-3D24-4561-BE16-FDDB4BCACCB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7AB6D3-53A3-4C5B-A5A8-E26885CF1AF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7D1580-D3E3-4713-8BC5-ED59EEBE182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F0A639-55AA-437A-BB0A-4F5D1282502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F15A00-2AE5-4D5C-9EC4-2A2387049F6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4E5D83-E48E-4F1C-8465-19441A9740E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559A0E-7C66-48EF-BA98-2F100C77FEA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065064-5708-40E8-BCA3-921D951F12E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59C235-23F8-42DA-988A-8344EC9387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ED5699-8EF0-46AE-8521-BE57B922F8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C9B6BC-630E-4962-ADB9-F97DF4CF336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C25E94B-40C3-4213-A5C3-6FEF9AC22B4F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2484360" y="528480"/>
          <a:ext cx="3960720" cy="5337360"/>
        </p:xfrm>
        <a:graphic>
          <a:graphicData uri="http://schemas.openxmlformats.org/drawingml/2006/table">
            <a:tbl>
              <a:tblPr/>
              <a:tblGrid>
                <a:gridCol w="1017720"/>
                <a:gridCol w="952560"/>
                <a:gridCol w="1036440"/>
                <a:gridCol w="954000"/>
              </a:tblGrid>
              <a:tr h="184320">
                <a:tc>
                  <a:txBody>
                    <a:bodyPr lIns="48600" rIns="486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E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Paramet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8600" marR="48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8600" rIns="486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E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Irs2+/+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8600" marR="48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8600" rIns="486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E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Irs2+/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8600" marR="48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8600" rIns="486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E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Irs2-/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8600" marR="48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8280">
                <a:tc>
                  <a:txBody>
                    <a:bodyPr lIns="48600" rIns="48600" tIns="0" bIns="0" anchor="t">
                      <a:noAutofit/>
                    </a:bodyPr>
                    <a:p>
                      <a:pPr algn="just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8600" marR="48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8600" rIns="48600" tIns="0" bIns="0" anchor="t">
                      <a:noAutofit/>
                    </a:bodyPr>
                    <a:p>
                      <a:pPr algn="just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8600" marR="48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8600" rIns="486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E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MAL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8600" marR="48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8600" rIns="48600" tIns="0" bIns="0" anchor="t">
                      <a:noAutofit/>
                    </a:bodyPr>
                    <a:p>
                      <a:pPr algn="just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8600" marR="48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36560">
                <a:tc>
                  <a:txBody>
                    <a:bodyPr lIns="48600" rIns="486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E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Left Kidney weight (g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8600" marR="48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8600" rIns="486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E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0.1317+/-0.011 (8)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E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*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8600" marR="48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8600" rIns="486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E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0.128+/- 0.004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E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(8)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E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*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8600" marR="48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8600" rIns="486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E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0.08 +/- 0.003 (8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8600" marR="48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52600">
                <a:tc>
                  <a:txBody>
                    <a:bodyPr lIns="48600" rIns="486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E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Body weight at harvest (g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8600" marR="48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8600" rIns="486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E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19.816 +/- 1.127 (8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8600" marR="48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8600" rIns="486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E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20.426 +/- 0.588 (**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8600" marR="48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8600" rIns="486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E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16.868 +/- 0.241 (8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8600" marR="48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919080">
                <a:tc>
                  <a:txBody>
                    <a:bodyPr lIns="48600" rIns="486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E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Left kidney:body weight ratio (g/kg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8600" marR="48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8600" rIns="486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E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6.647 +/- 0.253 (8)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E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*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8600" marR="48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8600" rIns="486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E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6.246 +/- 0.122 (8)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E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*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8600" marR="48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8600" rIns="486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E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4.742 +/- 0.181 (8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8600" marR="48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68280">
                <a:tc>
                  <a:txBody>
                    <a:bodyPr lIns="48600" rIns="48600" tIns="0" bIns="0" anchor="t">
                      <a:noAutofit/>
                    </a:bodyPr>
                    <a:p>
                      <a:pPr algn="just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8600" marR="48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8600" rIns="48600" tIns="0" bIns="0" anchor="t">
                      <a:noAutofit/>
                    </a:bodyPr>
                    <a:p>
                      <a:pPr algn="just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8600" marR="48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8600" rIns="48600" tIns="0" bIns="0" anchor="t">
                      <a:noAutofit/>
                    </a:bodyPr>
                    <a:p>
                      <a:pPr algn="just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E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FEMAL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8600" marR="48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8600" rIns="48600" tIns="0" bIns="0" anchor="t">
                      <a:noAutofit/>
                    </a:bodyPr>
                    <a:p>
                      <a:pPr algn="just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8600" marR="48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736560">
                <a:tc>
                  <a:txBody>
                    <a:bodyPr lIns="48600" rIns="486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E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Left Kidney weight (g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8600" marR="48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8600" rIns="486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E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0.094 +/-0.004 (7)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E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8600" marR="48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8600" rIns="486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E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0.093 +/- 0.003 (7)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E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8600" marR="48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8600" rIns="486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E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0.0729 +/- 0.004 (7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8600" marR="48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550800">
                <a:tc>
                  <a:txBody>
                    <a:bodyPr lIns="48600" rIns="486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E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Body weight at harvest (g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8600" marR="48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8600" rIns="486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E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16.21 +/- 0.704 (7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8600" marR="48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8600" rIns="486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E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16.534 +/- 0.541 (7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8600" marR="48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8600" rIns="486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E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15.463 +/- 0.923 (7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8600" marR="48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920880">
                <a:tc>
                  <a:txBody>
                    <a:bodyPr lIns="48600" rIns="486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IE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Left kidney:body weight ratio (g/kg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8600" marR="48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8600" rIns="486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E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5.832 +/- 0.189 (7)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E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*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8600" marR="48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8600" rIns="486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E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5.635 +/- 0.181 (7)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E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*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8600" marR="48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48600" rIns="48600" tIns="0" bIns="0" anchor="t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IE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바탕"/>
                        </a:rPr>
                        <a:t>4.764 +/- 0.284 (7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48600" marR="48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Rectangle 1"/>
          <p:cNvSpPr/>
          <p:nvPr/>
        </p:nvSpPr>
        <p:spPr>
          <a:xfrm>
            <a:off x="677520" y="5963400"/>
            <a:ext cx="8287200" cy="70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IE" sz="1000" spc="-1" strike="noStrike">
                <a:solidFill>
                  <a:srgbClr val="000000"/>
                </a:solidFill>
                <a:latin typeface="Times New Roman"/>
                <a:ea typeface="바탕"/>
              </a:rPr>
              <a:t>Additional File 1 Table S1</a:t>
            </a:r>
            <a:r>
              <a:rPr b="0" lang="en-IE" sz="1000" spc="-1" strike="noStrike">
                <a:solidFill>
                  <a:srgbClr val="000000"/>
                </a:solidFill>
                <a:latin typeface="Times New Roman"/>
                <a:ea typeface="바탕"/>
              </a:rPr>
              <a:t>. Whole body and left kidney weights of 5-6 male and female </a:t>
            </a:r>
            <a:r>
              <a:rPr b="0" i="1" lang="en-IE" sz="1000" spc="-1" strike="noStrike">
                <a:solidFill>
                  <a:srgbClr val="000000"/>
                </a:solidFill>
                <a:latin typeface="Irs2"/>
                <a:ea typeface="바탕"/>
              </a:rPr>
              <a:t>Irs2</a:t>
            </a:r>
            <a:r>
              <a:rPr b="0" lang="en-IE" sz="1000" spc="-1" strike="noStrike" baseline="30000">
                <a:solidFill>
                  <a:srgbClr val="000000"/>
                </a:solidFill>
                <a:latin typeface="Times New Roman"/>
                <a:ea typeface="바탕"/>
              </a:rPr>
              <a:t>+/+</a:t>
            </a:r>
            <a:r>
              <a:rPr b="0" lang="en-IE" sz="1000" spc="-1" strike="noStrike">
                <a:solidFill>
                  <a:srgbClr val="000000"/>
                </a:solidFill>
                <a:latin typeface="Times New Roman"/>
                <a:ea typeface="바탕"/>
              </a:rPr>
              <a:t>, </a:t>
            </a:r>
            <a:r>
              <a:rPr b="0" i="1" lang="en-IE" sz="1000" spc="-1" strike="noStrike">
                <a:solidFill>
                  <a:srgbClr val="000000"/>
                </a:solidFill>
                <a:latin typeface="Irs2"/>
                <a:ea typeface="바탕"/>
              </a:rPr>
              <a:t>Irs2</a:t>
            </a:r>
            <a:r>
              <a:rPr b="0" lang="en-IE" sz="1000" spc="-1" strike="noStrike" baseline="30000">
                <a:solidFill>
                  <a:srgbClr val="000000"/>
                </a:solidFill>
                <a:latin typeface="Times New Roman"/>
                <a:ea typeface="바탕"/>
              </a:rPr>
              <a:t>+/-</a:t>
            </a:r>
            <a:r>
              <a:rPr b="0" lang="en-IE" sz="1000" spc="-1" strike="noStrike">
                <a:solidFill>
                  <a:srgbClr val="000000"/>
                </a:solidFill>
                <a:latin typeface="Times New Roman"/>
                <a:ea typeface="바탕"/>
              </a:rPr>
              <a:t> and </a:t>
            </a:r>
            <a:r>
              <a:rPr b="0" i="1" lang="en-IE" sz="1000" spc="-1" strike="noStrike">
                <a:solidFill>
                  <a:srgbClr val="000000"/>
                </a:solidFill>
                <a:latin typeface="Irs2"/>
                <a:ea typeface="바탕"/>
              </a:rPr>
              <a:t>Irs2</a:t>
            </a:r>
            <a:r>
              <a:rPr b="0" lang="en-IE" sz="1000" spc="-1" strike="noStrike" baseline="30000">
                <a:solidFill>
                  <a:srgbClr val="000000"/>
                </a:solidFill>
                <a:latin typeface="Times New Roman"/>
                <a:ea typeface="바탕"/>
              </a:rPr>
              <a:t>-/-</a:t>
            </a:r>
            <a:r>
              <a:rPr b="0" lang="en-IE" sz="1000" spc="-1" strike="noStrike">
                <a:solidFill>
                  <a:srgbClr val="000000"/>
                </a:solidFill>
                <a:latin typeface="Times New Roman"/>
                <a:ea typeface="바탕"/>
              </a:rPr>
              <a:t> mice were measured at the time of sacrifice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000" spc="-1" strike="noStrike">
                <a:solidFill>
                  <a:srgbClr val="000000"/>
                </a:solidFill>
                <a:latin typeface="Times New Roman"/>
                <a:ea typeface="바탕"/>
              </a:rPr>
              <a:t>Left kidney-to-body weight ratios were calculated and expressed as g/kg. Data were plotted as mean +/- SEM, with the number of animals in each grou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000" spc="-1" strike="noStrike">
                <a:solidFill>
                  <a:srgbClr val="000000"/>
                </a:solidFill>
                <a:latin typeface="Times New Roman"/>
                <a:ea typeface="바탕"/>
              </a:rPr>
              <a:t> </a:t>
            </a:r>
            <a:r>
              <a:rPr b="0" lang="en-IE" sz="1000" spc="-1" strike="noStrike">
                <a:solidFill>
                  <a:srgbClr val="000000"/>
                </a:solidFill>
                <a:latin typeface="Times New Roman"/>
                <a:ea typeface="바탕"/>
              </a:rPr>
              <a:t>indicated in brackets. Statistical significance was determined using one-way ANOVA and post hoc Tukey-Kramer multiple comparison test, * p&lt; 0.05,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IE" sz="1000" spc="-1" strike="noStrike">
                <a:solidFill>
                  <a:srgbClr val="000000"/>
                </a:solidFill>
                <a:latin typeface="Times New Roman"/>
                <a:ea typeface="바탕"/>
              </a:rPr>
              <a:t>** p&lt; 0.01, *** p&lt; 0.001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19T11:41:47Z</dcterms:created>
  <dc:creator>QUB</dc:creator>
  <dc:description/>
  <dc:language>en-US</dc:language>
  <cp:lastModifiedBy>QUB</cp:lastModifiedBy>
  <dcterms:modified xsi:type="dcterms:W3CDTF">2010-06-27T11:41:32Z</dcterms:modified>
  <cp:revision>6</cp:revision>
  <dc:subject/>
  <dc:title>Slide 1</dc:title>
</cp:coreProperties>
</file>